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84" r:id="rId3"/>
    <p:sldId id="285" r:id="rId4"/>
  </p:sldIdLst>
  <p:sldSz cx="10972800" cy="13716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68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3384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2244726"/>
            <a:ext cx="9326880" cy="477520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7204076"/>
            <a:ext cx="8229600" cy="331152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640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44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1" y="730250"/>
            <a:ext cx="236601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1" y="730250"/>
            <a:ext cx="6960870" cy="1162367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877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258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6" y="3419479"/>
            <a:ext cx="9464040" cy="570547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6" y="9178929"/>
            <a:ext cx="9464040" cy="300037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782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3651250"/>
            <a:ext cx="466344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3651250"/>
            <a:ext cx="466344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586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730253"/>
            <a:ext cx="946404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3362326"/>
            <a:ext cx="4642008" cy="164782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5010150"/>
            <a:ext cx="4642008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1" y="3362326"/>
            <a:ext cx="4664869" cy="164782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1" y="5010150"/>
            <a:ext cx="4664869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627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074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992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14400"/>
            <a:ext cx="3539014" cy="32004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1974853"/>
            <a:ext cx="5554980" cy="97472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114800"/>
            <a:ext cx="3539014" cy="762317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108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14400"/>
            <a:ext cx="3539014" cy="32004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1974853"/>
            <a:ext cx="5554980" cy="97472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114800"/>
            <a:ext cx="3539014" cy="762317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917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730253"/>
            <a:ext cx="946404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3651250"/>
            <a:ext cx="946404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12712703"/>
            <a:ext cx="24688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32DA0-DEE0-407D-88B4-5B1B097165DB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12712703"/>
            <a:ext cx="37033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12712703"/>
            <a:ext cx="24688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B643C-D603-4724-9DB5-1D0BB735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54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oleObject" Target="../embeddings/oleObject5.bin"/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12" Type="http://schemas.openxmlformats.org/officeDocument/2006/relationships/image" Target="../media/image6.tif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microsoft.com/office/2007/relationships/hdphoto" Target="../media/hdphoto1.wdp"/><Relationship Id="rId5" Type="http://schemas.openxmlformats.org/officeDocument/2006/relationships/image" Target="../media/image2.wmf"/><Relationship Id="rId15" Type="http://schemas.openxmlformats.org/officeDocument/2006/relationships/image" Target="../media/image8.emf"/><Relationship Id="rId10" Type="http://schemas.openxmlformats.org/officeDocument/2006/relationships/image" Target="../media/image5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wmf"/><Relationship Id="rId14" Type="http://schemas.openxmlformats.org/officeDocument/2006/relationships/image" Target="../media/image7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wmf"/><Relationship Id="rId7" Type="http://schemas.openxmlformats.org/officeDocument/2006/relationships/image" Target="../media/image11.w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10.wmf"/><Relationship Id="rId4" Type="http://schemas.openxmlformats.org/officeDocument/2006/relationships/oleObject" Target="../embeddings/oleObject7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wmf"/><Relationship Id="rId4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683DF31E-5C28-4D7C-B74F-D9B6B8959A22}"/>
              </a:ext>
            </a:extLst>
          </p:cNvPr>
          <p:cNvCxnSpPr/>
          <p:nvPr/>
        </p:nvCxnSpPr>
        <p:spPr>
          <a:xfrm>
            <a:off x="1206193" y="11587449"/>
            <a:ext cx="1828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7720137" y="56633"/>
            <a:ext cx="30925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/>
        </p:nvGraphicFramePr>
        <p:xfrm>
          <a:off x="1177127" y="503694"/>
          <a:ext cx="4734843" cy="3896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3901320" imgH="2986920" progId="Origin50.Graph">
                  <p:embed/>
                </p:oleObj>
              </mc:Choice>
              <mc:Fallback>
                <p:oleObj name="Graph" r:id="rId2" imgW="3901320" imgH="2986920" progId="Origin50.Graph">
                  <p:embed/>
                  <p:pic>
                    <p:nvPicPr>
                      <p:cNvPr id="31" name="Object 3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77127" y="503694"/>
                        <a:ext cx="4734843" cy="38967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/>
        </p:nvGraphicFramePr>
        <p:xfrm>
          <a:off x="5390835" y="503694"/>
          <a:ext cx="4734843" cy="3896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4" imgW="3901320" imgH="2986920" progId="">
                  <p:embed/>
                </p:oleObj>
              </mc:Choice>
              <mc:Fallback>
                <p:oleObj name="Graph" r:id="rId4" imgW="3901320" imgH="2986920" progId="">
                  <p:embed/>
                  <p:pic>
                    <p:nvPicPr>
                      <p:cNvPr id="30" name="Object 2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90835" y="503694"/>
                        <a:ext cx="4734843" cy="3896787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4165368" y="2068130"/>
            <a:ext cx="2957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iastolic, mmHg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300609" y="3992131"/>
            <a:ext cx="1304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ime, day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656585" y="3126600"/>
            <a:ext cx="10054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>
                <a:solidFill>
                  <a:srgbClr val="0B32D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% NaCl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708287" y="3438665"/>
            <a:ext cx="2609382" cy="91793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 flipV="1">
            <a:off x="6702742" y="1518894"/>
            <a:ext cx="0" cy="2131644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039926" y="3907588"/>
            <a:ext cx="1304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ime, days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-48384" y="2032303"/>
            <a:ext cx="29413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ystolic, mmHg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499078" y="3440403"/>
            <a:ext cx="2571194" cy="91793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36778" y="3106523"/>
            <a:ext cx="10054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>
                <a:solidFill>
                  <a:srgbClr val="0B32D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% NaCl</a:t>
            </a:r>
          </a:p>
        </p:txBody>
      </p:sp>
      <p:cxnSp>
        <p:nvCxnSpPr>
          <p:cNvPr id="17" name="Straight Connector 16"/>
          <p:cNvCxnSpPr/>
          <p:nvPr/>
        </p:nvCxnSpPr>
        <p:spPr>
          <a:xfrm flipV="1">
            <a:off x="2490045" y="1520330"/>
            <a:ext cx="0" cy="2131644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1826597" y="4016955"/>
            <a:ext cx="170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NPPA-/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N=7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826597" y="4276526"/>
            <a:ext cx="1563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S WT (N=6)</a:t>
            </a:r>
          </a:p>
        </p:txBody>
      </p:sp>
      <p:sp>
        <p:nvSpPr>
          <p:cNvPr id="20" name="Right Brace 19"/>
          <p:cNvSpPr/>
          <p:nvPr/>
        </p:nvSpPr>
        <p:spPr>
          <a:xfrm rot="16200000">
            <a:off x="8261738" y="209182"/>
            <a:ext cx="90098" cy="197036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321607" y="857470"/>
            <a:ext cx="197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2" name="Oval 21"/>
          <p:cNvSpPr/>
          <p:nvPr/>
        </p:nvSpPr>
        <p:spPr>
          <a:xfrm>
            <a:off x="1659459" y="4160164"/>
            <a:ext cx="113864" cy="122391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1568882" y="4223345"/>
            <a:ext cx="948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1764327" y="4216689"/>
            <a:ext cx="948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Oval 24"/>
          <p:cNvSpPr/>
          <p:nvPr/>
        </p:nvSpPr>
        <p:spPr>
          <a:xfrm>
            <a:off x="1659459" y="4515473"/>
            <a:ext cx="113864" cy="122391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1568882" y="4578654"/>
            <a:ext cx="948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773630" y="4581999"/>
            <a:ext cx="948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ight Brace 27"/>
          <p:cNvSpPr/>
          <p:nvPr/>
        </p:nvSpPr>
        <p:spPr>
          <a:xfrm rot="16200000">
            <a:off x="3513547" y="-569751"/>
            <a:ext cx="127352" cy="294418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118310" y="533853"/>
            <a:ext cx="2944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0" name="Right Brace 29"/>
          <p:cNvSpPr/>
          <p:nvPr/>
        </p:nvSpPr>
        <p:spPr>
          <a:xfrm rot="16200000">
            <a:off x="6476651" y="2217662"/>
            <a:ext cx="90098" cy="37875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401686" y="2124193"/>
            <a:ext cx="165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837915" y="1513260"/>
            <a:ext cx="2318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ight Bracket 32"/>
          <p:cNvSpPr/>
          <p:nvPr/>
        </p:nvSpPr>
        <p:spPr>
          <a:xfrm rot="16200000">
            <a:off x="6900424" y="1768496"/>
            <a:ext cx="92634" cy="232563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9411977"/>
              </p:ext>
            </p:extLst>
          </p:nvPr>
        </p:nvGraphicFramePr>
        <p:xfrm>
          <a:off x="1360183" y="4803074"/>
          <a:ext cx="4317101" cy="34618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6" imgW="3901320" imgH="2986920" progId="Origin50.Graph">
                  <p:embed/>
                </p:oleObj>
              </mc:Choice>
              <mc:Fallback>
                <p:oleObj name="Graph" r:id="rId6" imgW="3901320" imgH="2986920" progId="Origin50.Graph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60183" y="4803074"/>
                        <a:ext cx="4317101" cy="34618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181161"/>
              </p:ext>
            </p:extLst>
          </p:nvPr>
        </p:nvGraphicFramePr>
        <p:xfrm>
          <a:off x="5618229" y="4896994"/>
          <a:ext cx="4317101" cy="34618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8" imgW="3901320" imgH="2986920" progId="Origin50.Graph">
                  <p:embed/>
                </p:oleObj>
              </mc:Choice>
              <mc:Fallback>
                <p:oleObj name="Graph" r:id="rId8" imgW="3901320" imgH="2986920" progId="Origin50.Graph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618229" y="4896994"/>
                        <a:ext cx="4317101" cy="34618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35"/>
          <p:cNvSpPr txBox="1"/>
          <p:nvPr/>
        </p:nvSpPr>
        <p:spPr>
          <a:xfrm rot="16200000">
            <a:off x="4449948" y="6354533"/>
            <a:ext cx="27837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AP, mmHg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094625" y="5388243"/>
            <a:ext cx="186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S, 8w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448279" y="5004978"/>
            <a:ext cx="7711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-3</a:t>
            </a:r>
          </a:p>
        </p:txBody>
      </p:sp>
      <p:sp>
        <p:nvSpPr>
          <p:cNvPr id="40" name="Rectangle 39"/>
          <p:cNvSpPr/>
          <p:nvPr/>
        </p:nvSpPr>
        <p:spPr>
          <a:xfrm>
            <a:off x="4680233" y="5416447"/>
            <a:ext cx="460033" cy="2574893"/>
          </a:xfrm>
          <a:prstGeom prst="rect">
            <a:avLst/>
          </a:prstGeom>
          <a:solidFill>
            <a:schemeClr val="bg1">
              <a:lumMod val="50000"/>
              <a:alpha val="36863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2833330" y="5402972"/>
            <a:ext cx="460033" cy="2587558"/>
          </a:xfrm>
          <a:prstGeom prst="rect">
            <a:avLst/>
          </a:prstGeom>
          <a:solidFill>
            <a:schemeClr val="bg1">
              <a:lumMod val="50000"/>
              <a:alpha val="36863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3752588" y="5417444"/>
            <a:ext cx="460033" cy="2571721"/>
          </a:xfrm>
          <a:prstGeom prst="rect">
            <a:avLst/>
          </a:prstGeom>
          <a:solidFill>
            <a:schemeClr val="bg1">
              <a:lumMod val="50000"/>
              <a:alpha val="36863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198081" y="6276914"/>
            <a:ext cx="27837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AP, mmHg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392343" y="4997555"/>
            <a:ext cx="7828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-2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313956" y="4993712"/>
            <a:ext cx="7750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-1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6714762" y="4994696"/>
            <a:ext cx="765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19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620161" y="4994920"/>
            <a:ext cx="8156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20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8575888" y="4993834"/>
            <a:ext cx="7786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y 21</a:t>
            </a:r>
          </a:p>
        </p:txBody>
      </p:sp>
      <p:sp>
        <p:nvSpPr>
          <p:cNvPr id="57" name="Right Bracket 56"/>
          <p:cNvSpPr/>
          <p:nvPr/>
        </p:nvSpPr>
        <p:spPr>
          <a:xfrm rot="16200000">
            <a:off x="2786062" y="4927182"/>
            <a:ext cx="67173" cy="899668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58" name="Right Bracket 57"/>
          <p:cNvSpPr/>
          <p:nvPr/>
        </p:nvSpPr>
        <p:spPr>
          <a:xfrm rot="16200000">
            <a:off x="3715208" y="4943011"/>
            <a:ext cx="68348" cy="874281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59" name="Right Bracket 58"/>
          <p:cNvSpPr/>
          <p:nvPr/>
        </p:nvSpPr>
        <p:spPr>
          <a:xfrm rot="16200000">
            <a:off x="4645276" y="4932745"/>
            <a:ext cx="72833" cy="894201"/>
          </a:xfrm>
          <a:prstGeom prst="righ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grpSp>
        <p:nvGrpSpPr>
          <p:cNvPr id="60" name="Group 59"/>
          <p:cNvGrpSpPr/>
          <p:nvPr/>
        </p:nvGrpSpPr>
        <p:grpSpPr>
          <a:xfrm>
            <a:off x="6691493" y="5337878"/>
            <a:ext cx="2705442" cy="62739"/>
            <a:chOff x="7336380" y="2978885"/>
            <a:chExt cx="2957658" cy="94301"/>
          </a:xfrm>
        </p:grpSpPr>
        <p:sp>
          <p:nvSpPr>
            <p:cNvPr id="61" name="Right Bracket 60"/>
            <p:cNvSpPr/>
            <p:nvPr/>
          </p:nvSpPr>
          <p:spPr>
            <a:xfrm rot="16200000">
              <a:off x="7739907" y="2575359"/>
              <a:ext cx="93949" cy="901003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62" name="Right Bracket 61"/>
            <p:cNvSpPr/>
            <p:nvPr/>
          </p:nvSpPr>
          <p:spPr>
            <a:xfrm rot="16200000">
              <a:off x="8763135" y="2575710"/>
              <a:ext cx="93949" cy="901003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63" name="Right Bracket 62"/>
            <p:cNvSpPr/>
            <p:nvPr/>
          </p:nvSpPr>
          <p:spPr>
            <a:xfrm rot="16200000">
              <a:off x="9796562" y="2575358"/>
              <a:ext cx="93949" cy="901003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</p:grpSp>
      <p:sp>
        <p:nvSpPr>
          <p:cNvPr id="64" name="TextBox 63"/>
          <p:cNvSpPr txBox="1"/>
          <p:nvPr/>
        </p:nvSpPr>
        <p:spPr>
          <a:xfrm>
            <a:off x="2296473" y="7384923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3679567" y="738167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3289119" y="7381677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4637474" y="737384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2767895" y="738167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4174927" y="7379631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6540946" y="7410784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7924041" y="741391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7533593" y="7415483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8881947" y="740921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7012368" y="741704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8419400" y="7412350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cxnSp>
        <p:nvCxnSpPr>
          <p:cNvPr id="76" name="Straight Connector 75"/>
          <p:cNvCxnSpPr/>
          <p:nvPr/>
        </p:nvCxnSpPr>
        <p:spPr>
          <a:xfrm>
            <a:off x="2373375" y="7987071"/>
            <a:ext cx="2765148" cy="263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flipH="1">
            <a:off x="2373375" y="7987072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H="1">
            <a:off x="2834709" y="7990701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 flipH="1">
            <a:off x="3289062" y="7990701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flipH="1">
            <a:off x="3755123" y="7988886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 flipH="1">
            <a:off x="4209477" y="7987072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 flipH="1">
            <a:off x="4684170" y="7990701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 flipH="1">
            <a:off x="5138523" y="7987072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2160047" y="8089493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2620014" y="8094331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pm</a:t>
            </a:r>
          </a:p>
        </p:txBody>
      </p:sp>
      <p:sp>
        <p:nvSpPr>
          <p:cNvPr id="86" name="Rectangle 85"/>
          <p:cNvSpPr/>
          <p:nvPr/>
        </p:nvSpPr>
        <p:spPr>
          <a:xfrm>
            <a:off x="2137696" y="5398967"/>
            <a:ext cx="232194" cy="2587558"/>
          </a:xfrm>
          <a:prstGeom prst="rect">
            <a:avLst/>
          </a:prstGeom>
          <a:solidFill>
            <a:schemeClr val="bg1">
              <a:lumMod val="50000"/>
              <a:alpha val="36863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074184" y="8104945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3534152" y="8109782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pm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4013592" y="8114460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4473559" y="8119297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pm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4910248" y="8124113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grpSp>
        <p:nvGrpSpPr>
          <p:cNvPr id="92" name="Group 91"/>
          <p:cNvGrpSpPr/>
          <p:nvPr/>
        </p:nvGrpSpPr>
        <p:grpSpPr>
          <a:xfrm>
            <a:off x="6401989" y="5398856"/>
            <a:ext cx="2985761" cy="2587669"/>
            <a:chOff x="7035127" y="2976522"/>
            <a:chExt cx="3264110" cy="2723505"/>
          </a:xfrm>
        </p:grpSpPr>
        <p:sp>
          <p:nvSpPr>
            <p:cNvPr id="93" name="Rectangle 92"/>
            <p:cNvSpPr/>
            <p:nvPr/>
          </p:nvSpPr>
          <p:spPr>
            <a:xfrm>
              <a:off x="7766382" y="2976522"/>
              <a:ext cx="502920" cy="2717378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8770497" y="2982649"/>
              <a:ext cx="502920" cy="2717378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94"/>
            <p:cNvSpPr/>
            <p:nvPr/>
          </p:nvSpPr>
          <p:spPr>
            <a:xfrm>
              <a:off x="9796317" y="2982649"/>
              <a:ext cx="502920" cy="2717378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95"/>
            <p:cNvSpPr/>
            <p:nvPr/>
          </p:nvSpPr>
          <p:spPr>
            <a:xfrm>
              <a:off x="7035127" y="2982649"/>
              <a:ext cx="253840" cy="2717378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97" name="Straight Connector 96"/>
          <p:cNvCxnSpPr/>
          <p:nvPr/>
        </p:nvCxnSpPr>
        <p:spPr>
          <a:xfrm>
            <a:off x="6616004" y="7978022"/>
            <a:ext cx="2765148" cy="263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 flipH="1">
            <a:off x="6616002" y="7978023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 flipH="1">
            <a:off x="7077337" y="7981651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flipH="1">
            <a:off x="7531690" y="7981651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 flipH="1">
            <a:off x="7997750" y="7979838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flipH="1">
            <a:off x="8452105" y="7978023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flipH="1">
            <a:off x="8926797" y="7981651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flipH="1">
            <a:off x="9381150" y="7978023"/>
            <a:ext cx="0" cy="1227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6402674" y="8080443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6862641" y="8086214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pm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7316813" y="8091984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7776780" y="8097754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pm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8256220" y="8103523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8716187" y="8109292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pm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9152876" y="8115064"/>
            <a:ext cx="4977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am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6332324" y="5343395"/>
            <a:ext cx="186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S, 11w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920054" y="460131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1016573" y="498813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12" name="Picture 111">
            <a:extLst>
              <a:ext uri="{FF2B5EF4-FFF2-40B4-BE49-F238E27FC236}">
                <a16:creationId xmlns:a16="http://schemas.microsoft.com/office/drawing/2014/main" id="{F4C2E1D2-9D0A-4C99-94DD-129B7DFDFF4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277" t="4268" r="38253" b="12038"/>
          <a:stretch/>
        </p:blipFill>
        <p:spPr>
          <a:xfrm rot="5400000">
            <a:off x="3264221" y="10291847"/>
            <a:ext cx="1072506" cy="482441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14" name="Picture 113">
            <a:extLst>
              <a:ext uri="{FF2B5EF4-FFF2-40B4-BE49-F238E27FC236}">
                <a16:creationId xmlns:a16="http://schemas.microsoft.com/office/drawing/2014/main" id="{2DD44678-5243-4874-9BC9-3D29D5F2C0F8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36" t="66355" r="5228" b="18646"/>
          <a:stretch/>
        </p:blipFill>
        <p:spPr>
          <a:xfrm>
            <a:off x="1381810" y="11136906"/>
            <a:ext cx="4810125" cy="69952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15" name="TextBox 114">
            <a:extLst>
              <a:ext uri="{FF2B5EF4-FFF2-40B4-BE49-F238E27FC236}">
                <a16:creationId xmlns:a16="http://schemas.microsoft.com/office/drawing/2014/main" id="{47D6A64E-74BC-4449-BCDE-9D801FA0CD82}"/>
              </a:ext>
            </a:extLst>
          </p:cNvPr>
          <p:cNvSpPr txBox="1"/>
          <p:nvPr/>
        </p:nvSpPr>
        <p:spPr>
          <a:xfrm>
            <a:off x="886278" y="10998696"/>
            <a:ext cx="443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64CE4CBD-825A-46E7-80F8-BA5D97350AA7}"/>
              </a:ext>
            </a:extLst>
          </p:cNvPr>
          <p:cNvSpPr txBox="1"/>
          <p:nvPr/>
        </p:nvSpPr>
        <p:spPr>
          <a:xfrm>
            <a:off x="883611" y="11177189"/>
            <a:ext cx="443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4C161EB1-B071-448E-AD8E-DBD4B0DF1E37}"/>
              </a:ext>
            </a:extLst>
          </p:cNvPr>
          <p:cNvSpPr txBox="1"/>
          <p:nvPr/>
        </p:nvSpPr>
        <p:spPr>
          <a:xfrm>
            <a:off x="881008" y="11453442"/>
            <a:ext cx="4431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B282809D-63EC-49F2-8DAB-C3707439531F}"/>
              </a:ext>
            </a:extLst>
          </p:cNvPr>
          <p:cNvCxnSpPr/>
          <p:nvPr/>
        </p:nvCxnSpPr>
        <p:spPr>
          <a:xfrm flipH="1">
            <a:off x="6250171" y="11520993"/>
            <a:ext cx="70485" cy="254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CCF82349-1FA1-400C-8DAB-0B5DC255CEFC}"/>
              </a:ext>
            </a:extLst>
          </p:cNvPr>
          <p:cNvCxnSpPr>
            <a:cxnSpLocks/>
          </p:cNvCxnSpPr>
          <p:nvPr/>
        </p:nvCxnSpPr>
        <p:spPr>
          <a:xfrm flipH="1">
            <a:off x="2550583" y="10772810"/>
            <a:ext cx="16744" cy="535184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64C28728-FA12-4EC9-A148-42E2D47C3F6D}"/>
              </a:ext>
            </a:extLst>
          </p:cNvPr>
          <p:cNvCxnSpPr>
            <a:cxnSpLocks/>
          </p:cNvCxnSpPr>
          <p:nvPr/>
        </p:nvCxnSpPr>
        <p:spPr>
          <a:xfrm flipH="1">
            <a:off x="3769350" y="10768047"/>
            <a:ext cx="11633" cy="539947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E36DE453-CBC5-4528-9C25-95517C2DEF82}"/>
              </a:ext>
            </a:extLst>
          </p:cNvPr>
          <p:cNvCxnSpPr>
            <a:cxnSpLocks/>
          </p:cNvCxnSpPr>
          <p:nvPr/>
        </p:nvCxnSpPr>
        <p:spPr>
          <a:xfrm flipH="1">
            <a:off x="4991292" y="10768047"/>
            <a:ext cx="27686" cy="492259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FBFAD791-2160-4ED9-8238-B7B3084908A3}"/>
              </a:ext>
            </a:extLst>
          </p:cNvPr>
          <p:cNvSpPr txBox="1"/>
          <p:nvPr/>
        </p:nvSpPr>
        <p:spPr>
          <a:xfrm>
            <a:off x="1259948" y="11863702"/>
            <a:ext cx="25713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ierce Staining, total protein</a:t>
            </a: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E2325043-3E74-4D12-9595-CED330A80BE8}"/>
              </a:ext>
            </a:extLst>
          </p:cNvPr>
          <p:cNvSpPr/>
          <p:nvPr/>
        </p:nvSpPr>
        <p:spPr>
          <a:xfrm>
            <a:off x="1360183" y="10773177"/>
            <a:ext cx="1170432" cy="26683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1400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885D370D-F74C-4997-A46B-CD34FE448914}"/>
              </a:ext>
            </a:extLst>
          </p:cNvPr>
          <p:cNvSpPr/>
          <p:nvPr/>
        </p:nvSpPr>
        <p:spPr>
          <a:xfrm>
            <a:off x="2569360" y="10773685"/>
            <a:ext cx="1170432" cy="26581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en-US" sz="1400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E2749F5-5B02-4AA9-AF6A-D6D70F081D97}"/>
              </a:ext>
            </a:extLst>
          </p:cNvPr>
          <p:cNvSpPr txBox="1"/>
          <p:nvPr/>
        </p:nvSpPr>
        <p:spPr>
          <a:xfrm>
            <a:off x="1369105" y="10416699"/>
            <a:ext cx="2372859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6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0A48252A-CDFC-414F-A1C6-F488100FFC98}"/>
              </a:ext>
            </a:extLst>
          </p:cNvPr>
          <p:cNvSpPr txBox="1"/>
          <p:nvPr/>
        </p:nvSpPr>
        <p:spPr>
          <a:xfrm>
            <a:off x="3792358" y="10416699"/>
            <a:ext cx="2399591" cy="3385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S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NPPA-/-</a:t>
            </a: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B21D5045-75C2-4F89-BD1E-855939FD190C}"/>
              </a:ext>
            </a:extLst>
          </p:cNvPr>
          <p:cNvCxnSpPr/>
          <p:nvPr/>
        </p:nvCxnSpPr>
        <p:spPr>
          <a:xfrm>
            <a:off x="1197095" y="11139288"/>
            <a:ext cx="1828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5503EA39-5FB0-4789-B4E5-C649DC36F953}"/>
              </a:ext>
            </a:extLst>
          </p:cNvPr>
          <p:cNvCxnSpPr/>
          <p:nvPr/>
        </p:nvCxnSpPr>
        <p:spPr>
          <a:xfrm>
            <a:off x="1197095" y="11310673"/>
            <a:ext cx="18288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Rectangle 131">
            <a:extLst>
              <a:ext uri="{FF2B5EF4-FFF2-40B4-BE49-F238E27FC236}">
                <a16:creationId xmlns:a16="http://schemas.microsoft.com/office/drawing/2014/main" id="{6B9C9149-EE60-4B38-8A4E-7EB581C32D1D}"/>
              </a:ext>
            </a:extLst>
          </p:cNvPr>
          <p:cNvSpPr/>
          <p:nvPr/>
        </p:nvSpPr>
        <p:spPr>
          <a:xfrm>
            <a:off x="3792358" y="10773177"/>
            <a:ext cx="1170432" cy="26683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1400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57A42C54-4789-4142-9E6F-A8887805815B}"/>
              </a:ext>
            </a:extLst>
          </p:cNvPr>
          <p:cNvSpPr/>
          <p:nvPr/>
        </p:nvSpPr>
        <p:spPr>
          <a:xfrm>
            <a:off x="5001535" y="10773685"/>
            <a:ext cx="1170432" cy="265814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en-US" sz="1400" baseline="30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33335A0C-6276-4C0B-975F-ABE583142A0A}"/>
              </a:ext>
            </a:extLst>
          </p:cNvPr>
          <p:cNvSpPr txBox="1"/>
          <p:nvPr/>
        </p:nvSpPr>
        <p:spPr>
          <a:xfrm>
            <a:off x="689657" y="1012227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36" name="Object 135">
            <a:extLst>
              <a:ext uri="{FF2B5EF4-FFF2-40B4-BE49-F238E27FC236}">
                <a16:creationId xmlns:a16="http://schemas.microsoft.com/office/drawing/2014/main" id="{5B2913E6-1D6D-43D1-8A92-CB4FB6E1C9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8685539"/>
              </p:ext>
            </p:extLst>
          </p:nvPr>
        </p:nvGraphicFramePr>
        <p:xfrm>
          <a:off x="6453035" y="10321968"/>
          <a:ext cx="4090318" cy="31438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13" imgW="9753480" imgH="7467480" progId="Origin50.Graph">
                  <p:embed/>
                </p:oleObj>
              </mc:Choice>
              <mc:Fallback>
                <p:oleObj name="Graph" r:id="rId13" imgW="9753480" imgH="7467480" progId="Origin50.Graph">
                  <p:embed/>
                  <p:pic>
                    <p:nvPicPr>
                      <p:cNvPr id="195" name="Object 194">
                        <a:extLst>
                          <a:ext uri="{FF2B5EF4-FFF2-40B4-BE49-F238E27FC236}">
                            <a16:creationId xmlns:a16="http://schemas.microsoft.com/office/drawing/2014/main" id="{EDE37FD4-983D-4600-B776-84A9577F963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453035" y="10321968"/>
                        <a:ext cx="4090318" cy="31438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7" name="TextBox 136">
            <a:extLst>
              <a:ext uri="{FF2B5EF4-FFF2-40B4-BE49-F238E27FC236}">
                <a16:creationId xmlns:a16="http://schemas.microsoft.com/office/drawing/2014/main" id="{12457441-BBF6-48CF-90CD-1DBD4CC488B5}"/>
              </a:ext>
            </a:extLst>
          </p:cNvPr>
          <p:cNvSpPr txBox="1"/>
          <p:nvPr/>
        </p:nvSpPr>
        <p:spPr>
          <a:xfrm rot="16200000">
            <a:off x="5163900" y="11939675"/>
            <a:ext cx="3056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ensitometry, 15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au</a:t>
            </a:r>
          </a:p>
        </p:txBody>
      </p: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E52B0530-4919-4E11-AC92-D2A686D1ADF7}"/>
              </a:ext>
            </a:extLst>
          </p:cNvPr>
          <p:cNvGrpSpPr/>
          <p:nvPr/>
        </p:nvGrpSpPr>
        <p:grpSpPr>
          <a:xfrm>
            <a:off x="7206051" y="12992082"/>
            <a:ext cx="2858782" cy="752538"/>
            <a:chOff x="2109789" y="3905518"/>
            <a:chExt cx="2699381" cy="739033"/>
          </a:xfrm>
        </p:grpSpPr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534F76D6-E1C8-4858-8D0C-D923371E6CD9}"/>
                </a:ext>
              </a:extLst>
            </p:cNvPr>
            <p:cNvSpPr/>
            <p:nvPr/>
          </p:nvSpPr>
          <p:spPr>
            <a:xfrm>
              <a:off x="2109789" y="3905518"/>
              <a:ext cx="711584" cy="3324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S-11</a:t>
              </a:r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77F2B0F8-4991-4EAF-ABFF-694B32213867}"/>
                </a:ext>
              </a:extLst>
            </p:cNvPr>
            <p:cNvSpPr/>
            <p:nvPr/>
          </p:nvSpPr>
          <p:spPr>
            <a:xfrm>
              <a:off x="2788031" y="3913913"/>
              <a:ext cx="711584" cy="3324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HS-11</a:t>
              </a:r>
            </a:p>
          </p:txBody>
        </p: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02D4AE57-A50C-4AD1-8563-0E8B6B1929D1}"/>
                </a:ext>
              </a:extLst>
            </p:cNvPr>
            <p:cNvSpPr/>
            <p:nvPr/>
          </p:nvSpPr>
          <p:spPr>
            <a:xfrm>
              <a:off x="3441333" y="3918218"/>
              <a:ext cx="711584" cy="3324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S-11</a:t>
              </a:r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FA7D3E7D-C773-42F4-BF62-9168598D1927}"/>
                </a:ext>
              </a:extLst>
            </p:cNvPr>
            <p:cNvSpPr/>
            <p:nvPr/>
          </p:nvSpPr>
          <p:spPr>
            <a:xfrm>
              <a:off x="4097586" y="3917951"/>
              <a:ext cx="711584" cy="33247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HS-11</a:t>
              </a:r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C4873948-7AC1-4D09-B0B4-9B84BC2998E6}"/>
                </a:ext>
              </a:extLst>
            </p:cNvPr>
            <p:cNvSpPr/>
            <p:nvPr/>
          </p:nvSpPr>
          <p:spPr>
            <a:xfrm>
              <a:off x="2352596" y="4294286"/>
              <a:ext cx="907300" cy="33247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S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64149DD5-44C9-4A9D-835C-096ED2459101}"/>
                </a:ext>
              </a:extLst>
            </p:cNvPr>
            <p:cNvSpPr/>
            <p:nvPr/>
          </p:nvSpPr>
          <p:spPr>
            <a:xfrm>
              <a:off x="3724881" y="4312073"/>
              <a:ext cx="894162" cy="33247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S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PPA-/-</a:t>
              </a:r>
            </a:p>
          </p:txBody>
        </p:sp>
        <p:sp>
          <p:nvSpPr>
            <p:cNvPr id="149" name="Right Bracket 148">
              <a:extLst>
                <a:ext uri="{FF2B5EF4-FFF2-40B4-BE49-F238E27FC236}">
                  <a16:creationId xmlns:a16="http://schemas.microsoft.com/office/drawing/2014/main" id="{22777E9C-5AE5-4CEC-9FC8-5FC9805292AA}"/>
                </a:ext>
              </a:extLst>
            </p:cNvPr>
            <p:cNvSpPr/>
            <p:nvPr/>
          </p:nvSpPr>
          <p:spPr>
            <a:xfrm rot="5400000" flipV="1">
              <a:off x="2745944" y="3928887"/>
              <a:ext cx="77838" cy="67259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50" name="Right Bracket 149">
              <a:extLst>
                <a:ext uri="{FF2B5EF4-FFF2-40B4-BE49-F238E27FC236}">
                  <a16:creationId xmlns:a16="http://schemas.microsoft.com/office/drawing/2014/main" id="{FE2F3B8D-9916-43FB-B913-7D7DEED26089}"/>
                </a:ext>
              </a:extLst>
            </p:cNvPr>
            <p:cNvSpPr/>
            <p:nvPr/>
          </p:nvSpPr>
          <p:spPr>
            <a:xfrm rot="5400000" flipV="1">
              <a:off x="4091032" y="3936859"/>
              <a:ext cx="77838" cy="67259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FAB29FF-ED75-4F70-9279-848C660BAA21}"/>
              </a:ext>
            </a:extLst>
          </p:cNvPr>
          <p:cNvGrpSpPr/>
          <p:nvPr/>
        </p:nvGrpSpPr>
        <p:grpSpPr>
          <a:xfrm>
            <a:off x="6908582" y="10585836"/>
            <a:ext cx="2449985" cy="377592"/>
            <a:chOff x="7352326" y="9670024"/>
            <a:chExt cx="1430934" cy="377592"/>
          </a:xfrm>
        </p:grpSpPr>
        <p:sp>
          <p:nvSpPr>
            <p:cNvPr id="156" name="Right Bracket 155">
              <a:extLst>
                <a:ext uri="{FF2B5EF4-FFF2-40B4-BE49-F238E27FC236}">
                  <a16:creationId xmlns:a16="http://schemas.microsoft.com/office/drawing/2014/main" id="{3A2B87B7-1371-4ACC-B45B-856744143392}"/>
                </a:ext>
              </a:extLst>
            </p:cNvPr>
            <p:cNvSpPr/>
            <p:nvPr/>
          </p:nvSpPr>
          <p:spPr>
            <a:xfrm rot="16200000">
              <a:off x="8080333" y="9628152"/>
              <a:ext cx="59659" cy="779269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000"/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E02AC11E-576F-4567-BF46-C0B2AA4E053B}"/>
                </a:ext>
              </a:extLst>
            </p:cNvPr>
            <p:cNvSpPr txBox="1"/>
            <p:nvPr/>
          </p:nvSpPr>
          <p:spPr>
            <a:xfrm>
              <a:off x="7352326" y="9670024"/>
              <a:ext cx="1430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>
                  <a:latin typeface="Arial" charset="0"/>
                  <a:ea typeface="Arial" charset="0"/>
                  <a:cs typeface="Arial" charset="0"/>
                </a:rPr>
                <a:t>p=0.03</a:t>
              </a:r>
            </a:p>
          </p:txBody>
        </p:sp>
      </p:grpSp>
      <p:pic>
        <p:nvPicPr>
          <p:cNvPr id="159" name="Picture 158">
            <a:extLst>
              <a:ext uri="{FF2B5EF4-FFF2-40B4-BE49-F238E27FC236}">
                <a16:creationId xmlns:a16="http://schemas.microsoft.com/office/drawing/2014/main" id="{F2DF9089-AD2C-44E2-B0BA-1F48FAF9085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98910" y="8727830"/>
            <a:ext cx="8574980" cy="12705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18784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03167" y="711940"/>
            <a:ext cx="7394005" cy="3439858"/>
            <a:chOff x="-43258" y="634410"/>
            <a:chExt cx="8008689" cy="3731282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/>
          </p:nvGraphicFramePr>
          <p:xfrm>
            <a:off x="3449888" y="634410"/>
            <a:ext cx="4515543" cy="36161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Graph" r:id="rId2" imgW="3901320" imgH="2986920" progId="Origin50.Graph">
                    <p:embed/>
                  </p:oleObj>
                </mc:Choice>
                <mc:Fallback>
                  <p:oleObj name="Graph" r:id="rId2" imgW="3901320" imgH="2986920" progId="Origin50.Graph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449888" y="634410"/>
                          <a:ext cx="4515543" cy="36161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/>
          </p:nvGraphicFramePr>
          <p:xfrm>
            <a:off x="0" y="641050"/>
            <a:ext cx="4514850" cy="361632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Graph" r:id="rId4" imgW="3901320" imgH="2986920" progId="Origin50.Graph">
                    <p:embed/>
                  </p:oleObj>
                </mc:Choice>
                <mc:Fallback>
                  <p:oleObj name="Graph" r:id="rId4" imgW="3901320" imgH="2986920" progId="Origin50.Graph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0" y="641050"/>
                          <a:ext cx="4514850" cy="361632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-1173293" y="1956060"/>
              <a:ext cx="2693441" cy="4333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[FITC-inulin], µg/mL 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2774856" y="3931685"/>
              <a:ext cx="1408597" cy="4340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Time, min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6221302" y="3922735"/>
              <a:ext cx="1408597" cy="4340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Time, min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53878" y="920220"/>
              <a:ext cx="1186251" cy="434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S</a:t>
              </a:r>
              <a:r>
                <a:rPr lang="en-US" sz="2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4517558" y="858632"/>
              <a:ext cx="1238443" cy="43400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S</a:t>
              </a:r>
              <a:r>
                <a:rPr lang="en-US" sz="2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PPA-/-</a:t>
              </a: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1817073" y="2467272"/>
              <a:ext cx="628281" cy="126813"/>
              <a:chOff x="5262562" y="1258602"/>
              <a:chExt cx="542925" cy="104775"/>
            </a:xfrm>
          </p:grpSpPr>
          <p:cxnSp>
            <p:nvCxnSpPr>
              <p:cNvPr id="16" name="Straight Connector 15"/>
              <p:cNvCxnSpPr/>
              <p:nvPr/>
            </p:nvCxnSpPr>
            <p:spPr>
              <a:xfrm>
                <a:off x="5262562" y="1310990"/>
                <a:ext cx="54292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Oval 16"/>
              <p:cNvSpPr/>
              <p:nvPr/>
            </p:nvSpPr>
            <p:spPr>
              <a:xfrm>
                <a:off x="5481634" y="1258602"/>
                <a:ext cx="104775" cy="104775"/>
              </a:xfrm>
              <a:prstGeom prst="ellipse">
                <a:avLst/>
              </a:prstGeom>
              <a:solidFill>
                <a:srgbClr val="007635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1817072" y="2783901"/>
              <a:ext cx="628281" cy="126813"/>
              <a:chOff x="5262561" y="1386850"/>
              <a:chExt cx="542925" cy="104775"/>
            </a:xfrm>
          </p:grpSpPr>
          <p:cxnSp>
            <p:nvCxnSpPr>
              <p:cNvPr id="14" name="Straight Connector 13"/>
              <p:cNvCxnSpPr/>
              <p:nvPr/>
            </p:nvCxnSpPr>
            <p:spPr>
              <a:xfrm>
                <a:off x="5262561" y="1438958"/>
                <a:ext cx="542925" cy="0"/>
              </a:xfrm>
              <a:prstGeom prst="line">
                <a:avLst/>
              </a:prstGeom>
              <a:ln w="9525"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Oval 14"/>
              <p:cNvSpPr/>
              <p:nvPr/>
            </p:nvSpPr>
            <p:spPr>
              <a:xfrm>
                <a:off x="5481634" y="1386850"/>
                <a:ext cx="104775" cy="104775"/>
              </a:xfrm>
              <a:prstGeom prst="ellipse">
                <a:avLst/>
              </a:prstGeom>
              <a:solidFill>
                <a:srgbClr val="0B32D7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/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2287659" y="2330638"/>
              <a:ext cx="1186251" cy="4006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0763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 diet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331749" y="2668162"/>
              <a:ext cx="1519377" cy="4006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B32D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, day 20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6975066" y="763704"/>
            <a:ext cx="4449352" cy="3210229"/>
            <a:chOff x="6730206" y="708570"/>
            <a:chExt cx="4449352" cy="3210229"/>
          </a:xfrm>
        </p:grpSpPr>
        <p:graphicFrame>
          <p:nvGraphicFramePr>
            <p:cNvPr id="19" name="Object 18"/>
            <p:cNvGraphicFramePr>
              <a:graphicFrameLocks noChangeAspect="1"/>
            </p:cNvGraphicFramePr>
            <p:nvPr/>
          </p:nvGraphicFramePr>
          <p:xfrm>
            <a:off x="6730206" y="708570"/>
            <a:ext cx="4449352" cy="321022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Graph" r:id="rId6" imgW="3901320" imgH="2986920" progId="Origin50.Graph">
                    <p:embed/>
                  </p:oleObj>
                </mc:Choice>
                <mc:Fallback>
                  <p:oleObj name="Graph" r:id="rId6" imgW="3901320" imgH="2986920" progId="Origin50.Graph">
                    <p:embed/>
                    <p:pic>
                      <p:nvPicPr>
                        <p:cNvPr id="19" name="Object 18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6730206" y="708570"/>
                          <a:ext cx="4449352" cy="321022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 rot="16200000">
              <a:off x="5511688" y="2116578"/>
              <a:ext cx="28655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GFR, ml/min/100 gBW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405717" y="1002632"/>
              <a:ext cx="10204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i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22" name="Right Bracket 21"/>
            <p:cNvSpPr/>
            <p:nvPr/>
          </p:nvSpPr>
          <p:spPr>
            <a:xfrm rot="16200000">
              <a:off x="9875640" y="969980"/>
              <a:ext cx="83910" cy="772101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Group 22"/>
            <p:cNvGrpSpPr/>
            <p:nvPr/>
          </p:nvGrpSpPr>
          <p:grpSpPr>
            <a:xfrm>
              <a:off x="7403934" y="897897"/>
              <a:ext cx="1808035" cy="423108"/>
              <a:chOff x="7436451" y="780713"/>
              <a:chExt cx="1808035" cy="423108"/>
            </a:xfrm>
          </p:grpSpPr>
          <p:sp>
            <p:nvSpPr>
              <p:cNvPr id="24" name="Right Bracket 23"/>
              <p:cNvSpPr/>
              <p:nvPr/>
            </p:nvSpPr>
            <p:spPr>
              <a:xfrm rot="16200000">
                <a:off x="8273794" y="775815"/>
                <a:ext cx="83910" cy="772101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436451" y="780713"/>
                <a:ext cx="18080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i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p=0.001</a:t>
                </a:r>
              </a:p>
            </p:txBody>
          </p:sp>
        </p:grpSp>
      </p:grpSp>
      <p:grpSp>
        <p:nvGrpSpPr>
          <p:cNvPr id="26" name="Group 25"/>
          <p:cNvGrpSpPr/>
          <p:nvPr/>
        </p:nvGrpSpPr>
        <p:grpSpPr>
          <a:xfrm>
            <a:off x="7654291" y="3439422"/>
            <a:ext cx="3332855" cy="845785"/>
            <a:chOff x="2148717" y="3905518"/>
            <a:chExt cx="2743846" cy="747442"/>
          </a:xfrm>
        </p:grpSpPr>
        <p:sp>
          <p:nvSpPr>
            <p:cNvPr id="27" name="Rectangle 26"/>
            <p:cNvSpPr/>
            <p:nvPr/>
          </p:nvSpPr>
          <p:spPr>
            <a:xfrm>
              <a:off x="2148717" y="3905518"/>
              <a:ext cx="633724" cy="3535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NS-8</a:t>
              </a: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2776074" y="3913913"/>
              <a:ext cx="735500" cy="3535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HS-11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480261" y="3918218"/>
              <a:ext cx="633724" cy="3535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NS-8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4085628" y="3917951"/>
              <a:ext cx="735500" cy="3535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HS-11</a:t>
              </a: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2352596" y="4294286"/>
              <a:ext cx="907300" cy="3535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S</a:t>
              </a:r>
              <a:r>
                <a:rPr lang="en-US" sz="2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3610387" y="4299373"/>
              <a:ext cx="1282176" cy="3535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SS</a:t>
              </a:r>
              <a:r>
                <a:rPr lang="en-US" sz="2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PPA-/-</a:t>
              </a:r>
            </a:p>
          </p:txBody>
        </p:sp>
        <p:sp>
          <p:nvSpPr>
            <p:cNvPr id="33" name="Right Bracket 32"/>
            <p:cNvSpPr/>
            <p:nvPr/>
          </p:nvSpPr>
          <p:spPr>
            <a:xfrm rot="5400000" flipV="1">
              <a:off x="2745944" y="3928887"/>
              <a:ext cx="77838" cy="67259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000"/>
            </a:p>
          </p:txBody>
        </p:sp>
        <p:sp>
          <p:nvSpPr>
            <p:cNvPr id="34" name="Right Bracket 33"/>
            <p:cNvSpPr/>
            <p:nvPr/>
          </p:nvSpPr>
          <p:spPr>
            <a:xfrm rot="5400000" flipV="1">
              <a:off x="4091032" y="3936859"/>
              <a:ext cx="77838" cy="67259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2000"/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7671276" y="38695"/>
            <a:ext cx="30925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42402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18695" y="1087670"/>
            <a:ext cx="8535731" cy="4236034"/>
            <a:chOff x="1545101" y="1663404"/>
            <a:chExt cx="6662614" cy="3124483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25798983"/>
                </p:ext>
              </p:extLst>
            </p:nvPr>
          </p:nvGraphicFramePr>
          <p:xfrm>
            <a:off x="4792431" y="1663404"/>
            <a:ext cx="3415284" cy="26149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Graph" r:id="rId2" imgW="3901320" imgH="2986920" progId="Origin50.Graph">
                    <p:embed/>
                  </p:oleObj>
                </mc:Choice>
                <mc:Fallback>
                  <p:oleObj name="Graph" r:id="rId2" imgW="3901320" imgH="2986920" progId="Origin50.Graph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792431" y="1663404"/>
                          <a:ext cx="3415284" cy="26149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1113859"/>
                </p:ext>
              </p:extLst>
            </p:nvPr>
          </p:nvGraphicFramePr>
          <p:xfrm>
            <a:off x="1545101" y="1665415"/>
            <a:ext cx="3415284" cy="26149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Graph" r:id="rId4" imgW="3901320" imgH="2986920" progId="Origin50.Graph">
                    <p:embed/>
                  </p:oleObj>
                </mc:Choice>
                <mc:Fallback>
                  <p:oleObj name="Graph" r:id="rId4" imgW="3901320" imgH="2986920" progId="Origin50.Graph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545101" y="1665415"/>
                          <a:ext cx="3415284" cy="26149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3974324" y="2692012"/>
              <a:ext cx="1981922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Heart rate, bpm 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5405574" y="2104091"/>
              <a:ext cx="186443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7429053" y="2106180"/>
              <a:ext cx="245308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5947287" y="2104091"/>
              <a:ext cx="363926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6695333" y="2110627"/>
              <a:ext cx="359012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160638" y="2104091"/>
              <a:ext cx="186443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4193789" y="2105371"/>
              <a:ext cx="232302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2707853" y="2104656"/>
              <a:ext cx="363926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3441961" y="2104656"/>
              <a:ext cx="363926" cy="1954530"/>
            </a:xfrm>
            <a:prstGeom prst="rect">
              <a:avLst/>
            </a:prstGeom>
            <a:solidFill>
              <a:schemeClr val="bg1">
                <a:lumMod val="50000"/>
                <a:alpha val="36863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732035" y="2670332"/>
              <a:ext cx="1981922" cy="298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Heart rate, 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pm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243861" y="1795315"/>
              <a:ext cx="626609" cy="204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-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002263" y="1788014"/>
              <a:ext cx="621491" cy="204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-2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730755" y="1780058"/>
              <a:ext cx="619823" cy="204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-1</a:t>
              </a: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2185117" y="3400316"/>
              <a:ext cx="1031840" cy="306181"/>
              <a:chOff x="2672010" y="3572312"/>
              <a:chExt cx="1375786" cy="408242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2900865" y="3572312"/>
                <a:ext cx="1146931" cy="2724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S WT (N=6)</a:t>
                </a:r>
              </a:p>
            </p:txBody>
          </p:sp>
          <p:sp>
            <p:nvSpPr>
              <p:cNvPr id="44" name="Oval 43"/>
              <p:cNvSpPr/>
              <p:nvPr/>
            </p:nvSpPr>
            <p:spPr>
              <a:xfrm>
                <a:off x="2759296" y="3870826"/>
                <a:ext cx="109728" cy="109728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" name="Straight Connector 44"/>
              <p:cNvCxnSpPr/>
              <p:nvPr/>
            </p:nvCxnSpPr>
            <p:spPr>
              <a:xfrm>
                <a:off x="2672010" y="3927471"/>
                <a:ext cx="9144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2860355" y="3921504"/>
                <a:ext cx="9144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Oval 46"/>
              <p:cNvSpPr/>
              <p:nvPr/>
            </p:nvSpPr>
            <p:spPr>
              <a:xfrm>
                <a:off x="2761136" y="3675523"/>
                <a:ext cx="109728" cy="109728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Straight Connector 47"/>
              <p:cNvCxnSpPr/>
              <p:nvPr/>
            </p:nvCxnSpPr>
            <p:spPr>
              <a:xfrm>
                <a:off x="2673850" y="3732168"/>
                <a:ext cx="9144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2871160" y="3735166"/>
                <a:ext cx="9144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" name="TextBox 18"/>
            <p:cNvSpPr txBox="1"/>
            <p:nvPr/>
          </p:nvSpPr>
          <p:spPr>
            <a:xfrm>
              <a:off x="5524212" y="1784344"/>
              <a:ext cx="621861" cy="204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19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251442" y="1790217"/>
              <a:ext cx="616968" cy="204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2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001461" y="1790217"/>
              <a:ext cx="624078" cy="204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 21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 rot="18884712">
              <a:off x="1441183" y="4022114"/>
              <a:ext cx="1134950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2am  - 6 am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18884712">
              <a:off x="1825327" y="4006860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am - 6 pm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 rot="18884712">
              <a:off x="2187020" y="4013956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pm - 6 am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rot="18884712">
              <a:off x="2504670" y="4021051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am - 6 pm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rot="18884712">
              <a:off x="2899129" y="4021052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pm - 6 am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 rot="18884712">
              <a:off x="3431262" y="4001308"/>
              <a:ext cx="1299576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pm – 12 am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 rot="18884712">
              <a:off x="3247025" y="4013956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am - 6 pm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 rot="18884712">
              <a:off x="4702594" y="4001899"/>
              <a:ext cx="1134950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2am  - 6 am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8884712">
              <a:off x="5100707" y="3992569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am - 6 pm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 rot="18884712">
              <a:off x="5457134" y="4007187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pm - 6 am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8884712">
              <a:off x="5802106" y="4006860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am - 6 pm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rot="18884712">
              <a:off x="6148130" y="4006862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pm - 6 am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8884712">
              <a:off x="6700761" y="4007991"/>
              <a:ext cx="1264190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pm – 12 am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8884712">
              <a:off x="6508592" y="4000837"/>
              <a:ext cx="1002819" cy="2735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6 am - 6 pm</a:t>
              </a:r>
            </a:p>
          </p:txBody>
        </p:sp>
        <p:sp>
          <p:nvSpPr>
            <p:cNvPr id="36" name="Right Bracket 35"/>
            <p:cNvSpPr/>
            <p:nvPr/>
          </p:nvSpPr>
          <p:spPr>
            <a:xfrm rot="16200000">
              <a:off x="2542796" y="1737380"/>
              <a:ext cx="67575" cy="65200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37" name="Right Bracket 36"/>
            <p:cNvSpPr/>
            <p:nvPr/>
          </p:nvSpPr>
          <p:spPr>
            <a:xfrm rot="16200000">
              <a:off x="3298142" y="1737464"/>
              <a:ext cx="67575" cy="65200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38" name="Right Bracket 37"/>
            <p:cNvSpPr/>
            <p:nvPr/>
          </p:nvSpPr>
          <p:spPr>
            <a:xfrm rot="16200000">
              <a:off x="4023430" y="1737380"/>
              <a:ext cx="67575" cy="65200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39" name="Right Bracket 38"/>
            <p:cNvSpPr/>
            <p:nvPr/>
          </p:nvSpPr>
          <p:spPr>
            <a:xfrm rot="16200000">
              <a:off x="5802808" y="1737464"/>
              <a:ext cx="67575" cy="65200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40" name="Right Bracket 39"/>
            <p:cNvSpPr/>
            <p:nvPr/>
          </p:nvSpPr>
          <p:spPr>
            <a:xfrm rot="16200000">
              <a:off x="6548242" y="1737464"/>
              <a:ext cx="67575" cy="65200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41" name="Right Bracket 40"/>
            <p:cNvSpPr/>
            <p:nvPr/>
          </p:nvSpPr>
          <p:spPr>
            <a:xfrm rot="16200000">
              <a:off x="7273796" y="1747402"/>
              <a:ext cx="67575" cy="65200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60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354468" y="3557383"/>
              <a:ext cx="917704" cy="2043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S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PPA-/-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N=7)</a:t>
              </a: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2473347" y="1626950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856441" y="162370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465993" y="1623704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814348" y="161587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2944769" y="162370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351801" y="1621658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6639824" y="1653816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8022919" y="165694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7632471" y="1658515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8980825" y="165224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7111246" y="166008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ctive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8518278" y="1655382"/>
            <a:ext cx="544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t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7548169" y="43268"/>
            <a:ext cx="30925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233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98</TotalTime>
  <Words>303</Words>
  <Application>Microsoft Office PowerPoint</Application>
  <PresentationFormat>Custom</PresentationFormat>
  <Paragraphs>124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Graph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latovskaya, Daria</dc:creator>
  <cp:lastModifiedBy>Ilatovskaya, Daria</cp:lastModifiedBy>
  <cp:revision>379</cp:revision>
  <cp:lastPrinted>2020-09-07T15:25:54Z</cp:lastPrinted>
  <dcterms:created xsi:type="dcterms:W3CDTF">2020-05-06T16:40:57Z</dcterms:created>
  <dcterms:modified xsi:type="dcterms:W3CDTF">2022-03-23T18:05:30Z</dcterms:modified>
</cp:coreProperties>
</file>